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37" d="100"/>
          <a:sy n="37" d="100"/>
        </p:scale>
        <p:origin x="204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329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989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149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719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704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9973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17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86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712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730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643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E7AC6-0F06-48C0-A9BF-092DA258951F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9974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B26BE463-9A85-29B8-1486-DDE12B8D52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399" b="47611"/>
          <a:stretch/>
        </p:blipFill>
        <p:spPr>
          <a:xfrm>
            <a:off x="302522" y="902286"/>
            <a:ext cx="6035648" cy="22796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02B1EB0-110F-5985-E5F3-5CC5B3E8BBCC}"/>
              </a:ext>
            </a:extLst>
          </p:cNvPr>
          <p:cNvSpPr txBox="1"/>
          <p:nvPr/>
        </p:nvSpPr>
        <p:spPr>
          <a:xfrm>
            <a:off x="302522" y="3662297"/>
            <a:ext cx="6035648" cy="1144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sequence chromatograms of six potential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mc1-D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SPR mutants from the T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, showing position of a 39 bp homozygous deletion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C1-D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wo of the mutants, DMC1_R1_A10 and DMC1_R1_C06. </a:t>
            </a: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BCB72ACA-1CF2-60D1-DC9B-DEA9C59E222A}"/>
              </a:ext>
            </a:extLst>
          </p:cNvPr>
          <p:cNvSpPr/>
          <p:nvPr/>
        </p:nvSpPr>
        <p:spPr>
          <a:xfrm rot="5400000">
            <a:off x="4767673" y="2585283"/>
            <a:ext cx="115858" cy="1302544"/>
          </a:xfrm>
          <a:prstGeom prst="rightBrace">
            <a:avLst/>
          </a:prstGeom>
          <a:ln w="127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3C72A4-C2B5-3B74-9277-F211BFCB972B}"/>
              </a:ext>
            </a:extLst>
          </p:cNvPr>
          <p:cNvSpPr txBox="1"/>
          <p:nvPr/>
        </p:nvSpPr>
        <p:spPr>
          <a:xfrm>
            <a:off x="4329113" y="3264922"/>
            <a:ext cx="1076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 bp deletion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4974549-FA45-1B09-D123-0E9D7B497AE7}"/>
              </a:ext>
            </a:extLst>
          </p:cNvPr>
          <p:cNvSpPr/>
          <p:nvPr/>
        </p:nvSpPr>
        <p:spPr>
          <a:xfrm>
            <a:off x="523875" y="2776545"/>
            <a:ext cx="433388" cy="128588"/>
          </a:xfrm>
          <a:prstGeom prst="rect">
            <a:avLst/>
          </a:prstGeom>
          <a:solidFill>
            <a:srgbClr val="FF7C80">
              <a:alpha val="26667"/>
            </a:srgb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0B70AD2-1C17-6686-8F12-E047ADB538D1}"/>
              </a:ext>
            </a:extLst>
          </p:cNvPr>
          <p:cNvSpPr/>
          <p:nvPr/>
        </p:nvSpPr>
        <p:spPr>
          <a:xfrm>
            <a:off x="523875" y="2470768"/>
            <a:ext cx="433388" cy="128588"/>
          </a:xfrm>
          <a:prstGeom prst="rect">
            <a:avLst/>
          </a:prstGeom>
          <a:solidFill>
            <a:srgbClr val="FF7C80">
              <a:alpha val="26667"/>
            </a:srgb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E36828-C492-66F7-93BB-F05985B316EB}"/>
              </a:ext>
            </a:extLst>
          </p:cNvPr>
          <p:cNvSpPr txBox="1"/>
          <p:nvPr/>
        </p:nvSpPr>
        <p:spPr>
          <a:xfrm>
            <a:off x="200417" y="342779"/>
            <a:ext cx="3432130" cy="405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2168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</TotalTime>
  <Words>48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cie Draeger (JIC)</dc:creator>
  <cp:lastModifiedBy>Amy Tighe</cp:lastModifiedBy>
  <cp:revision>8</cp:revision>
  <dcterms:created xsi:type="dcterms:W3CDTF">2023-03-08T14:49:56Z</dcterms:created>
  <dcterms:modified xsi:type="dcterms:W3CDTF">2023-07-31T13:56:58Z</dcterms:modified>
</cp:coreProperties>
</file>